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9" r:id="rId4"/>
    <p:sldId id="258" r:id="rId5"/>
    <p:sldId id="260" r:id="rId6"/>
    <p:sldId id="262" r:id="rId7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1716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4" Type="http://schemas.openxmlformats.org/officeDocument/2006/relationships/image" Target="../media/image7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A79DF-AA51-49A6-9994-BC6F425EC0B9}" type="datetimeFigureOut">
              <a:rPr lang="de-DE" smtClean="0"/>
              <a:t>30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29C74-8C94-45F9-A9BE-0587600AD82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6709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A79DF-AA51-49A6-9994-BC6F425EC0B9}" type="datetimeFigureOut">
              <a:rPr lang="de-DE" smtClean="0"/>
              <a:t>30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29C74-8C94-45F9-A9BE-0587600AD82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3563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A79DF-AA51-49A6-9994-BC6F425EC0B9}" type="datetimeFigureOut">
              <a:rPr lang="de-DE" smtClean="0"/>
              <a:t>30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29C74-8C94-45F9-A9BE-0587600AD82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7529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A79DF-AA51-49A6-9994-BC6F425EC0B9}" type="datetimeFigureOut">
              <a:rPr lang="de-DE" smtClean="0"/>
              <a:t>30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29C74-8C94-45F9-A9BE-0587600AD82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1105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A79DF-AA51-49A6-9994-BC6F425EC0B9}" type="datetimeFigureOut">
              <a:rPr lang="de-DE" smtClean="0"/>
              <a:t>30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29C74-8C94-45F9-A9BE-0587600AD82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6146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A79DF-AA51-49A6-9994-BC6F425EC0B9}" type="datetimeFigureOut">
              <a:rPr lang="de-DE" smtClean="0"/>
              <a:t>30.03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29C74-8C94-45F9-A9BE-0587600AD82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4431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A79DF-AA51-49A6-9994-BC6F425EC0B9}" type="datetimeFigureOut">
              <a:rPr lang="de-DE" smtClean="0"/>
              <a:t>30.03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29C74-8C94-45F9-A9BE-0587600AD82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5395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A79DF-AA51-49A6-9994-BC6F425EC0B9}" type="datetimeFigureOut">
              <a:rPr lang="de-DE" smtClean="0"/>
              <a:t>30.03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29C74-8C94-45F9-A9BE-0587600AD82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4189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A79DF-AA51-49A6-9994-BC6F425EC0B9}" type="datetimeFigureOut">
              <a:rPr lang="de-DE" smtClean="0"/>
              <a:t>30.03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29C74-8C94-45F9-A9BE-0587600AD82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084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A79DF-AA51-49A6-9994-BC6F425EC0B9}" type="datetimeFigureOut">
              <a:rPr lang="de-DE" smtClean="0"/>
              <a:t>30.03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29C74-8C94-45F9-A9BE-0587600AD82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9396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A79DF-AA51-49A6-9994-BC6F425EC0B9}" type="datetimeFigureOut">
              <a:rPr lang="de-DE" smtClean="0"/>
              <a:t>30.03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29C74-8C94-45F9-A9BE-0587600AD82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60185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A79DF-AA51-49A6-9994-BC6F425EC0B9}" type="datetimeFigureOut">
              <a:rPr lang="de-DE" smtClean="0"/>
              <a:t>30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529C74-8C94-45F9-A9BE-0587600AD82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5334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3.bin"/><Relationship Id="rId10" Type="http://schemas.openxmlformats.org/officeDocument/2006/relationships/image" Target="../media/image7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5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6948264" y="210126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 err="1" smtClean="0"/>
              <a:t>Wiercinska</a:t>
            </a:r>
            <a:r>
              <a:rPr lang="en-US" sz="1600" dirty="0" smtClean="0"/>
              <a:t> et al.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468330" y="221739"/>
            <a:ext cx="19434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dditional </a:t>
            </a:r>
            <a:r>
              <a:rPr lang="en-US" dirty="0" smtClean="0"/>
              <a:t>Figure </a:t>
            </a:r>
            <a:r>
              <a:rPr lang="en-US" dirty="0" smtClean="0"/>
              <a:t>S1</a:t>
            </a:r>
            <a:r>
              <a:rPr lang="en-US" dirty="0" smtClean="0"/>
              <a:t>. </a:t>
            </a:r>
          </a:p>
        </p:txBody>
      </p:sp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8814390"/>
              </p:ext>
            </p:extLst>
          </p:nvPr>
        </p:nvGraphicFramePr>
        <p:xfrm>
          <a:off x="3132485" y="9599"/>
          <a:ext cx="3887787" cy="2627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Prism Project" r:id="rId3" imgW="3888000" imgH="2628000" progId="Prism5.Document">
                  <p:embed/>
                </p:oleObj>
              </mc:Choice>
              <mc:Fallback>
                <p:oleObj name="Prism Project" r:id="rId3" imgW="3888000" imgH="2628000" progId="Prism5.Document">
                  <p:embed/>
                  <p:pic>
                    <p:nvPicPr>
                      <p:cNvPr id="4" name="Objek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132485" y="9599"/>
                        <a:ext cx="3887787" cy="2627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0" y="5946665"/>
            <a:ext cx="91440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Suppl. Figure 1: </a:t>
            </a:r>
            <a:r>
              <a:rPr lang="en-US" sz="1100" b="1" dirty="0"/>
              <a:t>Impact of local differences in donor mobilization and apheresis management: </a:t>
            </a:r>
            <a:br>
              <a:rPr lang="en-US" sz="1100" b="1" dirty="0"/>
            </a:br>
            <a:r>
              <a:rPr lang="en-US" sz="1100" dirty="0"/>
              <a:t>For three European countries data on more than 5 HSPC products were available. Broken line represents the target of 4 x 10^6 CD34+ cells /kg recipient’s body weight. Each dot represents the patient’s total transplant dose (pre-freeze), i.e. the aggregate dose of CD34+ cells from one or two apheresis days. Median collected cell dose for the apheresis series is depicted. * Aggregate dose (1 or 2 apheresis days), ** </a:t>
            </a:r>
            <a:r>
              <a:rPr lang="en-US" sz="1100" dirty="0" smtClean="0"/>
              <a:t>was </a:t>
            </a:r>
            <a:r>
              <a:rPr lang="en-US" sz="1100" dirty="0"/>
              <a:t>not subjected to 2</a:t>
            </a:r>
            <a:r>
              <a:rPr lang="en-US" sz="1100" baseline="30000" dirty="0"/>
              <a:t>nd</a:t>
            </a:r>
            <a:r>
              <a:rPr lang="en-US" sz="1100" dirty="0"/>
              <a:t> day apheresis because of health </a:t>
            </a:r>
            <a:r>
              <a:rPr lang="en-US" sz="1100" dirty="0" smtClean="0"/>
              <a:t>conditions, </a:t>
            </a:r>
            <a:r>
              <a:rPr lang="en-US" sz="1100" b="1" dirty="0" smtClean="0">
                <a:solidFill>
                  <a:srgbClr val="FF0000"/>
                </a:solidFill>
              </a:rPr>
              <a:t>even though collecting only 3.8 x 10^6 CD34+/kg on day 1</a:t>
            </a:r>
            <a:r>
              <a:rPr lang="en-US" sz="1100" dirty="0" smtClean="0"/>
              <a:t>.</a:t>
            </a:r>
            <a:endParaRPr lang="de-DE" sz="1100" dirty="0"/>
          </a:p>
        </p:txBody>
      </p:sp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9710810"/>
              </p:ext>
            </p:extLst>
          </p:nvPr>
        </p:nvGraphicFramePr>
        <p:xfrm>
          <a:off x="244384" y="2348880"/>
          <a:ext cx="6343840" cy="3596636"/>
        </p:xfrm>
        <a:graphic>
          <a:graphicData uri="http://schemas.openxmlformats.org/drawingml/2006/table">
            <a:tbl>
              <a:tblPr firstRow="1" bandRow="1"/>
              <a:tblGrid>
                <a:gridCol w="3679544">
                  <a:extLst>
                    <a:ext uri="{9D8B030D-6E8A-4147-A177-3AD203B41FA5}">
                      <a16:colId xmlns:a16="http://schemas.microsoft.com/office/drawing/2014/main" xmlns="" val="3580109812"/>
                    </a:ext>
                  </a:extLst>
                </a:gridCol>
                <a:gridCol w="904784">
                  <a:extLst>
                    <a:ext uri="{9D8B030D-6E8A-4147-A177-3AD203B41FA5}">
                      <a16:colId xmlns:a16="http://schemas.microsoft.com/office/drawing/2014/main" xmlns="" val="411061207"/>
                    </a:ext>
                  </a:extLst>
                </a:gridCol>
                <a:gridCol w="883096">
                  <a:extLst>
                    <a:ext uri="{9D8B030D-6E8A-4147-A177-3AD203B41FA5}">
                      <a16:colId xmlns:a16="http://schemas.microsoft.com/office/drawing/2014/main" xmlns="" val="702256371"/>
                    </a:ext>
                  </a:extLst>
                </a:gridCol>
                <a:gridCol w="876416">
                  <a:extLst>
                    <a:ext uri="{9D8B030D-6E8A-4147-A177-3AD203B41FA5}">
                      <a16:colId xmlns:a16="http://schemas.microsoft.com/office/drawing/2014/main" xmlns="" val="851116483"/>
                    </a:ext>
                  </a:extLst>
                </a:gridCol>
              </a:tblGrid>
              <a:tr h="2381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ountry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95046410"/>
                  </a:ext>
                </a:extLst>
              </a:tr>
              <a:tr h="25199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ollection centers, n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0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77621509"/>
                  </a:ext>
                </a:extLst>
              </a:tr>
              <a:tr h="4065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Donors, number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emale donors, number (%)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8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0 (29%)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 (45%)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 (56%)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37851447"/>
                  </a:ext>
                </a:extLst>
              </a:tr>
              <a:tr h="51317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edian donor’s weight [kg]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ange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QR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8.5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1-126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9-88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2.0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8.0-105.0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2.5-94.0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7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6-94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0-82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02296055"/>
                  </a:ext>
                </a:extLst>
              </a:tr>
              <a:tr h="51317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ollected dose [x 10^6 CD34+/kg]*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ange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QR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.77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65-68.63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.24-10.42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.32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80-47.12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.36-16.37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.88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73-7.62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75-6.87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67904780"/>
                  </a:ext>
                </a:extLst>
              </a:tr>
              <a:tr h="269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umber </a:t>
                      </a:r>
                      <a:r>
                        <a:rPr lang="en-US" sz="900" b="1" kern="1200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of donors </a:t>
                      </a:r>
                      <a:r>
                        <a:rPr lang="en-US" sz="900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ith</a:t>
                      </a:r>
                      <a:r>
                        <a:rPr lang="de-DE" sz="900" kern="12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900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&lt;4 </a:t>
                      </a: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x 10^6 CD34+/kg* (%)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/68 (4%)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/11 (9%)**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/9 (33%)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66630237"/>
                  </a:ext>
                </a:extLst>
              </a:tr>
              <a:tr h="28039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umber of donors subjected to s</a:t>
                      </a: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cond day apheresis, number (%)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/68 (7%)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**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/9 (44%)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48498736"/>
                  </a:ext>
                </a:extLst>
              </a:tr>
              <a:tr h="50687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edian WBC conc. in product [x10^3/µL]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ange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QR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96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9-581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67-249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6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65-468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86-257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73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0-194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68-183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2098860"/>
                  </a:ext>
                </a:extLst>
              </a:tr>
              <a:tr h="56860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edian CD34+ frequency [%CD45+]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ange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QR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5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0-2.30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56-1.23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2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6-1.98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73-1.23</a:t>
                      </a:r>
                      <a:endParaRPr lang="de-DE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1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29-1.35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kern="1200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65-0.98</a:t>
                      </a:r>
                      <a:endParaRPr lang="de-DE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6910" marR="86910" marT="43455" marB="4345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549007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361968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8283" y="1700808"/>
            <a:ext cx="3895725" cy="3019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88507" y="1700808"/>
            <a:ext cx="3971925" cy="3019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0" y="5269743"/>
            <a:ext cx="9144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. Figure </a:t>
            </a:r>
            <a:r>
              <a:rPr lang="en-US" sz="1100" b="1" dirty="0" smtClean="0"/>
              <a:t>2: </a:t>
            </a:r>
            <a:r>
              <a:rPr lang="en-US" sz="1100" b="1" dirty="0"/>
              <a:t>Relationship between calculated post-thaw CD34+ cell dose and engraftment </a:t>
            </a:r>
            <a:br>
              <a:rPr lang="en-US" sz="1100" b="1" dirty="0"/>
            </a:br>
            <a:r>
              <a:rPr lang="en-US" sz="1100" dirty="0" err="1"/>
              <a:t>Engraftment</a:t>
            </a:r>
            <a:r>
              <a:rPr lang="en-US" sz="1100" dirty="0"/>
              <a:t> of neutrophils or platelets is not a function of transplanted CD34+ cell dose. Neutrophil engraftment was defined as the first of three consecutive days with neutrophil counts &gt;500/µL. Platelet engraftment was defined by the first of three consecutive days of unsupported platelet counts &gt;20,000/µL. Each dot represents one transplant (</a:t>
            </a:r>
            <a:r>
              <a:rPr lang="en-US" sz="1100" dirty="0" smtClean="0"/>
              <a:t>n=30 for A and n=28 for B).</a:t>
            </a:r>
            <a:endParaRPr lang="de-DE" sz="1100" dirty="0"/>
          </a:p>
        </p:txBody>
      </p:sp>
      <p:sp>
        <p:nvSpPr>
          <p:cNvPr id="7" name="Textfeld 6"/>
          <p:cNvSpPr txBox="1"/>
          <p:nvPr/>
        </p:nvSpPr>
        <p:spPr>
          <a:xfrm>
            <a:off x="6948264" y="210126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 err="1" smtClean="0"/>
              <a:t>Wiercinska</a:t>
            </a:r>
            <a:r>
              <a:rPr lang="en-US" sz="1600" dirty="0" smtClean="0"/>
              <a:t> et al.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468330" y="221739"/>
            <a:ext cx="19434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</a:t>
            </a:r>
            <a:r>
              <a:rPr lang="en-US" dirty="0" smtClean="0"/>
              <a:t>Figure </a:t>
            </a:r>
            <a:r>
              <a:rPr lang="en-US" dirty="0" smtClean="0"/>
              <a:t>S2</a:t>
            </a:r>
            <a:r>
              <a:rPr lang="en-US" dirty="0" smtClean="0"/>
              <a:t>. 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971600" y="1712997"/>
            <a:ext cx="409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. 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4716016" y="1700808"/>
            <a:ext cx="409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3017294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1701814"/>
              </p:ext>
            </p:extLst>
          </p:nvPr>
        </p:nvGraphicFramePr>
        <p:xfrm>
          <a:off x="3748244" y="764704"/>
          <a:ext cx="4208132" cy="24482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2" name="Prism Project" r:id="rId3" imgW="5076000" imgH="2952000" progId="Prism5.Document">
                  <p:embed/>
                </p:oleObj>
              </mc:Choice>
              <mc:Fallback>
                <p:oleObj name="Prism Project" r:id="rId3" imgW="5076000" imgH="2952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48244" y="764704"/>
                        <a:ext cx="4208132" cy="24482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0" y="5899919"/>
            <a:ext cx="91440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. Figure 3</a:t>
            </a:r>
            <a:r>
              <a:rPr lang="en-US" sz="1100" b="1" dirty="0" smtClean="0"/>
              <a:t>: </a:t>
            </a:r>
            <a:r>
              <a:rPr lang="en-US" sz="1100" b="1" dirty="0"/>
              <a:t>Relationship between calculated </a:t>
            </a:r>
            <a:r>
              <a:rPr lang="en-US" sz="1100" b="1" dirty="0" smtClean="0"/>
              <a:t>CD34</a:t>
            </a:r>
            <a:r>
              <a:rPr lang="en-US" sz="1100" b="1" dirty="0"/>
              <a:t>+ cell </a:t>
            </a:r>
            <a:r>
              <a:rPr lang="en-US" sz="1100" b="1" dirty="0" smtClean="0"/>
              <a:t>dose before cryopreservation </a:t>
            </a:r>
            <a:r>
              <a:rPr lang="en-US" sz="1100" b="1" dirty="0"/>
              <a:t>and engraftment </a:t>
            </a:r>
            <a:br>
              <a:rPr lang="en-US" sz="1100" b="1" dirty="0"/>
            </a:br>
            <a:r>
              <a:rPr lang="en-US" sz="1100" dirty="0"/>
              <a:t>Time to engraftment for neutrophils (</a:t>
            </a:r>
            <a:r>
              <a:rPr lang="en-US" sz="1100" dirty="0" smtClean="0"/>
              <a:t>A, C) </a:t>
            </a:r>
            <a:r>
              <a:rPr lang="en-US" sz="1100" dirty="0"/>
              <a:t>or thrombocytes (</a:t>
            </a:r>
            <a:r>
              <a:rPr lang="en-US" sz="1100" dirty="0" smtClean="0"/>
              <a:t>B, D) </a:t>
            </a:r>
            <a:r>
              <a:rPr lang="en-US" sz="1100" dirty="0"/>
              <a:t>was independent from </a:t>
            </a:r>
            <a:r>
              <a:rPr lang="en-US" sz="1100" dirty="0" smtClean="0"/>
              <a:t>the </a:t>
            </a:r>
            <a:r>
              <a:rPr lang="en-US" sz="1100" dirty="0"/>
              <a:t>dose of CD34+ </a:t>
            </a:r>
            <a:r>
              <a:rPr lang="en-US" sz="1100" dirty="0" smtClean="0"/>
              <a:t>cells before cryopreservation. Engraftment </a:t>
            </a:r>
            <a:r>
              <a:rPr lang="en-US" sz="1100" dirty="0"/>
              <a:t>of neutrophils or platelets is not a function of transplanted CD34+ cell dose. Neutrophil engraftment was defined as the first of three consecutive days with neutrophil counts &gt;500/µL. Platelet engraftment was defined by the first of three consecutive days of unsupported platelet counts &gt;20,000/µL. Each dot represents one transplant (</a:t>
            </a:r>
            <a:r>
              <a:rPr lang="en-US" sz="1100" dirty="0" smtClean="0"/>
              <a:t>n=30 for </a:t>
            </a:r>
            <a:r>
              <a:rPr lang="en-US" sz="1100" dirty="0"/>
              <a:t>C</a:t>
            </a:r>
            <a:r>
              <a:rPr lang="en-US" sz="1100" dirty="0" smtClean="0"/>
              <a:t>; n=28 for </a:t>
            </a:r>
            <a:r>
              <a:rPr lang="en-US" sz="1100" dirty="0"/>
              <a:t>D</a:t>
            </a:r>
            <a:r>
              <a:rPr lang="en-US" sz="1100" dirty="0" smtClean="0"/>
              <a:t>).</a:t>
            </a:r>
            <a:endParaRPr lang="de-DE" sz="1100" dirty="0"/>
          </a:p>
        </p:txBody>
      </p:sp>
      <p:sp>
        <p:nvSpPr>
          <p:cNvPr id="7" name="Textfeld 6"/>
          <p:cNvSpPr txBox="1"/>
          <p:nvPr/>
        </p:nvSpPr>
        <p:spPr>
          <a:xfrm>
            <a:off x="6948264" y="210126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 err="1" smtClean="0"/>
              <a:t>Wiercinska</a:t>
            </a:r>
            <a:r>
              <a:rPr lang="en-US" sz="1600" dirty="0" smtClean="0"/>
              <a:t> et al.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468330" y="221739"/>
            <a:ext cx="19434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gure S3</a:t>
            </a:r>
            <a:r>
              <a:rPr lang="en-US" dirty="0" smtClean="0"/>
              <a:t>. 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435443" y="755412"/>
            <a:ext cx="409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. 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3946731" y="743223"/>
            <a:ext cx="409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. </a:t>
            </a:r>
          </a:p>
        </p:txBody>
      </p:sp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8496306"/>
              </p:ext>
            </p:extLst>
          </p:nvPr>
        </p:nvGraphicFramePr>
        <p:xfrm>
          <a:off x="251520" y="3362555"/>
          <a:ext cx="3145628" cy="24427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3" name="Prism Project" r:id="rId5" imgW="3708000" imgH="2880000" progId="Prism5.Document">
                  <p:embed/>
                </p:oleObj>
              </mc:Choice>
              <mc:Fallback>
                <p:oleObj name="Prism Project" r:id="rId5" imgW="3708000" imgH="288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51520" y="3362555"/>
                        <a:ext cx="3145628" cy="24427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0907670"/>
              </p:ext>
            </p:extLst>
          </p:nvPr>
        </p:nvGraphicFramePr>
        <p:xfrm>
          <a:off x="3757189" y="3374096"/>
          <a:ext cx="3191075" cy="24311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4" name="Prism Project" r:id="rId7" imgW="3780000" imgH="2880000" progId="Prism5.Document">
                  <p:embed/>
                </p:oleObj>
              </mc:Choice>
              <mc:Fallback>
                <p:oleObj name="Prism Project" r:id="rId7" imgW="3780000" imgH="288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757189" y="3374096"/>
                        <a:ext cx="3191075" cy="24311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feld 13"/>
          <p:cNvSpPr txBox="1"/>
          <p:nvPr/>
        </p:nvSpPr>
        <p:spPr>
          <a:xfrm>
            <a:off x="435443" y="3297173"/>
            <a:ext cx="409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  <a:r>
              <a:rPr lang="en-US" dirty="0" smtClean="0"/>
              <a:t>. 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3946731" y="3284984"/>
            <a:ext cx="409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  <a:r>
              <a:rPr lang="en-US" dirty="0" smtClean="0"/>
              <a:t>. </a:t>
            </a:r>
          </a:p>
        </p:txBody>
      </p:sp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4124667"/>
              </p:ext>
            </p:extLst>
          </p:nvPr>
        </p:nvGraphicFramePr>
        <p:xfrm>
          <a:off x="253193" y="764704"/>
          <a:ext cx="3094671" cy="23577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5" name="Prism Project" r:id="rId9" imgW="3780000" imgH="2880000" progId="Prism5.Document">
                  <p:embed/>
                </p:oleObj>
              </mc:Choice>
              <mc:Fallback>
                <p:oleObj name="Prism Project" r:id="rId9" imgW="3780000" imgH="288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53193" y="764704"/>
                        <a:ext cx="3094671" cy="23577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264026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6948264" y="210126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 err="1" smtClean="0"/>
              <a:t>Wiercinska</a:t>
            </a:r>
            <a:r>
              <a:rPr lang="en-US" sz="1600" dirty="0" smtClean="0"/>
              <a:t> et al.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468330" y="221739"/>
            <a:ext cx="19434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gure S4</a:t>
            </a:r>
            <a:r>
              <a:rPr lang="en-US" dirty="0" smtClean="0"/>
              <a:t>. </a:t>
            </a:r>
          </a:p>
        </p:txBody>
      </p:sp>
      <p:sp>
        <p:nvSpPr>
          <p:cNvPr id="4" name="Textfeld 3"/>
          <p:cNvSpPr txBox="1"/>
          <p:nvPr/>
        </p:nvSpPr>
        <p:spPr>
          <a:xfrm>
            <a:off x="971600" y="1712997"/>
            <a:ext cx="409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. 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4716016" y="1700808"/>
            <a:ext cx="409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. </a:t>
            </a:r>
          </a:p>
        </p:txBody>
      </p:sp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8955582"/>
              </p:ext>
            </p:extLst>
          </p:nvPr>
        </p:nvGraphicFramePr>
        <p:xfrm>
          <a:off x="521841" y="1764392"/>
          <a:ext cx="3779837" cy="2879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6" name="Prism Project" r:id="rId3" imgW="3780000" imgH="2880000" progId="Prism5.Document">
                  <p:embed/>
                </p:oleObj>
              </mc:Choice>
              <mc:Fallback>
                <p:oleObj name="Prism Project" r:id="rId3" imgW="3780000" imgH="288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21841" y="1764392"/>
                        <a:ext cx="3779837" cy="2879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71830539"/>
              </p:ext>
            </p:extLst>
          </p:nvPr>
        </p:nvGraphicFramePr>
        <p:xfrm>
          <a:off x="4148338" y="1742305"/>
          <a:ext cx="4679950" cy="2952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7" name="Prism Project" r:id="rId5" imgW="4680000" imgH="2952000" progId="Prism5.Document">
                  <p:embed/>
                </p:oleObj>
              </mc:Choice>
              <mc:Fallback>
                <p:oleObj name="Prism Project" r:id="rId5" imgW="4680000" imgH="2952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48338" y="1742305"/>
                        <a:ext cx="4679950" cy="2952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feld 7"/>
          <p:cNvSpPr txBox="1"/>
          <p:nvPr/>
        </p:nvSpPr>
        <p:spPr>
          <a:xfrm>
            <a:off x="0" y="5899919"/>
            <a:ext cx="914400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. Figure </a:t>
            </a:r>
            <a:r>
              <a:rPr lang="en-US" sz="1100" b="1" dirty="0" smtClean="0"/>
              <a:t>4: </a:t>
            </a:r>
            <a:r>
              <a:rPr lang="en-US" sz="1100" b="1" dirty="0"/>
              <a:t>Relationship between calculated </a:t>
            </a:r>
            <a:r>
              <a:rPr lang="en-US" sz="1100" b="1" dirty="0" smtClean="0"/>
              <a:t>viable CD34</a:t>
            </a:r>
            <a:r>
              <a:rPr lang="en-US" sz="1100" b="1" dirty="0"/>
              <a:t>+ </a:t>
            </a:r>
            <a:r>
              <a:rPr lang="en-US" sz="1100" b="1" dirty="0" smtClean="0"/>
              <a:t>recovery </a:t>
            </a:r>
            <a:r>
              <a:rPr lang="en-US" sz="1100" b="1" dirty="0"/>
              <a:t>and engraftment </a:t>
            </a:r>
            <a:br>
              <a:rPr lang="en-US" sz="1100" b="1" dirty="0"/>
            </a:br>
            <a:r>
              <a:rPr lang="en-US" sz="1100" dirty="0" smtClean="0"/>
              <a:t>Patient cohort was split into two groups receiving products with recovery lower or greater than 42.2% (median recovery, see Table 2). The groups include 12 and 15 recipients, respectively. 3 Patients receiving two products (apheresis days 1 and 2) were excluded from the analysis. </a:t>
            </a:r>
            <a:endParaRPr lang="de-DE" sz="1100" dirty="0"/>
          </a:p>
        </p:txBody>
      </p:sp>
    </p:spTree>
    <p:extLst>
      <p:ext uri="{BB962C8B-B14F-4D97-AF65-F5344CB8AC3E}">
        <p14:creationId xmlns:p14="http://schemas.microsoft.com/office/powerpoint/2010/main" val="28040486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95536" y="221159"/>
            <a:ext cx="7704856" cy="538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</a:t>
            </a:r>
            <a:r>
              <a:rPr lang="en-US" dirty="0" smtClean="0"/>
              <a:t>Table </a:t>
            </a:r>
            <a:r>
              <a:rPr lang="en-US" dirty="0"/>
              <a:t>S1</a:t>
            </a:r>
            <a:r>
              <a:rPr lang="en-US" dirty="0" smtClean="0"/>
              <a:t>.</a:t>
            </a:r>
            <a:endParaRPr lang="de-DE" dirty="0"/>
          </a:p>
          <a:p>
            <a:r>
              <a:rPr lang="en-US" sz="1100" b="1" dirty="0" smtClean="0"/>
              <a:t>Specification </a:t>
            </a:r>
            <a:r>
              <a:rPr lang="en-US" sz="1100" b="1" dirty="0"/>
              <a:t>of licensed cryopreserved allogenic HPC </a:t>
            </a:r>
            <a:r>
              <a:rPr lang="en-US" sz="1100" b="1" dirty="0" smtClean="0"/>
              <a:t>products </a:t>
            </a:r>
          </a:p>
        </p:txBody>
      </p:sp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889915"/>
              </p:ext>
            </p:extLst>
          </p:nvPr>
        </p:nvGraphicFramePr>
        <p:xfrm>
          <a:off x="1835696" y="830308"/>
          <a:ext cx="6480720" cy="5911060"/>
        </p:xfrm>
        <a:graphic>
          <a:graphicData uri="http://schemas.openxmlformats.org/drawingml/2006/table">
            <a:tbl>
              <a:tblPr firstRow="1" firstCol="1"/>
              <a:tblGrid>
                <a:gridCol w="2967077">
                  <a:extLst>
                    <a:ext uri="{9D8B030D-6E8A-4147-A177-3AD203B41FA5}">
                      <a16:colId xmlns:a16="http://schemas.microsoft.com/office/drawing/2014/main" xmlns="" val="2668842452"/>
                    </a:ext>
                  </a:extLst>
                </a:gridCol>
                <a:gridCol w="3513643">
                  <a:extLst>
                    <a:ext uri="{9D8B030D-6E8A-4147-A177-3AD203B41FA5}">
                      <a16:colId xmlns:a16="http://schemas.microsoft.com/office/drawing/2014/main" xmlns="" val="4212228978"/>
                    </a:ext>
                  </a:extLst>
                </a:gridCol>
              </a:tblGrid>
              <a:tr h="21941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rameter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pecification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71740293"/>
                  </a:ext>
                </a:extLst>
              </a:tr>
              <a:tr h="219419"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ter collection before cryopreservation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797668581"/>
                  </a:ext>
                </a:extLst>
              </a:tr>
              <a:tr h="430351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olume in end product bag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termined/declared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rget: 50-400mL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55250182"/>
                  </a:ext>
                </a:extLst>
              </a:tr>
              <a:tr h="430351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umber of end product bags per transplant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clared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-2 per transplant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68638933"/>
                  </a:ext>
                </a:extLst>
              </a:tr>
              <a:tr h="641282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34+ cell dose per kg body weight of recipient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termined/declared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rget: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0% of the transplants: </a:t>
                      </a: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≥</a:t>
                      </a: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4 x 10^6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18450598"/>
                  </a:ext>
                </a:extLst>
              </a:tr>
              <a:tr h="21941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34+ cell number per bag and transplant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termined/declared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53594480"/>
                  </a:ext>
                </a:extLst>
              </a:tr>
              <a:tr h="21941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NC* number per bag and transplant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termined/declared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47016182"/>
                  </a:ext>
                </a:extLst>
              </a:tr>
              <a:tr h="430351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NC concentration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termined/declared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rget: ≤ 3 x 10^8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52856492"/>
                  </a:ext>
                </a:extLst>
              </a:tr>
              <a:tr h="430351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NC viability 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rget: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0% of the transplants: </a:t>
                      </a: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≥</a:t>
                      </a: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80%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33865087"/>
                  </a:ext>
                </a:extLst>
              </a:tr>
              <a:tr h="21941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3+ cell number per transplant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termined/declared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41251137"/>
                  </a:ext>
                </a:extLst>
              </a:tr>
              <a:tr h="430351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ematocrit (residue RBC)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termined/declared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rget: ≤ 10%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30385969"/>
                  </a:ext>
                </a:extLst>
              </a:tr>
              <a:tr h="52737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erility testing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rget: negative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f positive with species-level identification </a:t>
                      </a:r>
                      <a:r>
                        <a:rPr lang="en-US" sz="1050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en-US" sz="1050" kern="1200" baseline="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50" kern="1200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tibiogram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52092485"/>
                  </a:ext>
                </a:extLst>
              </a:tr>
              <a:tr h="21941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isual inspection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ag undamaged, no aggregates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5275466"/>
                  </a:ext>
                </a:extLst>
              </a:tr>
              <a:tr h="219419"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ter cryopreservation before release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365348926"/>
                  </a:ext>
                </a:extLst>
              </a:tr>
              <a:tr h="430351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NC viability</a:t>
                      </a:r>
                      <a:endParaRPr lang="de-DE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rget: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0% of the transplants: </a:t>
                      </a:r>
                      <a:r>
                        <a:rPr lang="en-US" sz="10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≥</a:t>
                      </a:r>
                      <a:r>
                        <a:rPr lang="en-US" sz="10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70%</a:t>
                      </a:r>
                      <a:endParaRPr lang="de-DE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5628" marR="45628" marT="7359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12651742"/>
                  </a:ext>
                </a:extLst>
              </a:tr>
            </a:tbl>
          </a:graphicData>
        </a:graphic>
      </p:graphicFrame>
      <p:sp>
        <p:nvSpPr>
          <p:cNvPr id="8" name="Textfeld 7"/>
          <p:cNvSpPr txBox="1"/>
          <p:nvPr/>
        </p:nvSpPr>
        <p:spPr>
          <a:xfrm>
            <a:off x="15244" y="6381328"/>
            <a:ext cx="2592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* </a:t>
            </a:r>
            <a:r>
              <a:rPr lang="en-US" sz="1200" dirty="0"/>
              <a:t>MNC, mononuclear </a:t>
            </a:r>
            <a:r>
              <a:rPr lang="en-US" sz="1200" dirty="0" smtClean="0"/>
              <a:t>cells</a:t>
            </a:r>
            <a:endParaRPr lang="de-DE" sz="1200" dirty="0"/>
          </a:p>
        </p:txBody>
      </p:sp>
      <p:sp>
        <p:nvSpPr>
          <p:cNvPr id="9" name="Textfeld 8"/>
          <p:cNvSpPr txBox="1"/>
          <p:nvPr/>
        </p:nvSpPr>
        <p:spPr>
          <a:xfrm>
            <a:off x="6948264" y="210126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 err="1" smtClean="0"/>
              <a:t>Wiercinska</a:t>
            </a:r>
            <a:r>
              <a:rPr lang="en-US" sz="1600" dirty="0" smtClean="0"/>
              <a:t> et al.</a:t>
            </a:r>
          </a:p>
        </p:txBody>
      </p:sp>
    </p:spTree>
    <p:extLst>
      <p:ext uri="{BB962C8B-B14F-4D97-AF65-F5344CB8AC3E}">
        <p14:creationId xmlns:p14="http://schemas.microsoft.com/office/powerpoint/2010/main" val="24949829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95536" y="221159"/>
            <a:ext cx="7704856" cy="538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</a:t>
            </a:r>
            <a:r>
              <a:rPr lang="en-US" dirty="0" smtClean="0"/>
              <a:t>Table </a:t>
            </a:r>
            <a:r>
              <a:rPr lang="en-US" dirty="0"/>
              <a:t>S2</a:t>
            </a:r>
            <a:r>
              <a:rPr lang="en-US" dirty="0" smtClean="0"/>
              <a:t>.</a:t>
            </a:r>
            <a:endParaRPr lang="de-DE" dirty="0"/>
          </a:p>
          <a:p>
            <a:r>
              <a:rPr lang="en-US" sz="1100" b="1" dirty="0"/>
              <a:t>Donor characteristics</a:t>
            </a:r>
            <a:endParaRPr lang="en-US" sz="1100" b="1" dirty="0" smtClean="0"/>
          </a:p>
        </p:txBody>
      </p:sp>
      <p:sp>
        <p:nvSpPr>
          <p:cNvPr id="9" name="Textfeld 8"/>
          <p:cNvSpPr txBox="1"/>
          <p:nvPr/>
        </p:nvSpPr>
        <p:spPr>
          <a:xfrm>
            <a:off x="6948264" y="210126"/>
            <a:ext cx="18722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 err="1" smtClean="0"/>
              <a:t>Wiercinska</a:t>
            </a:r>
            <a:r>
              <a:rPr lang="en-US" sz="1600" dirty="0" smtClean="0"/>
              <a:t> et al.</a:t>
            </a:r>
          </a:p>
        </p:txBody>
      </p:sp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5729393"/>
              </p:ext>
            </p:extLst>
          </p:nvPr>
        </p:nvGraphicFramePr>
        <p:xfrm>
          <a:off x="1979713" y="548680"/>
          <a:ext cx="5040559" cy="6034068"/>
        </p:xfrm>
        <a:graphic>
          <a:graphicData uri="http://schemas.openxmlformats.org/drawingml/2006/table">
            <a:tbl>
              <a:tblPr firstRow="1" firstCol="1" bandRow="1"/>
              <a:tblGrid>
                <a:gridCol w="1086738">
                  <a:extLst>
                    <a:ext uri="{9D8B030D-6E8A-4147-A177-3AD203B41FA5}">
                      <a16:colId xmlns:a16="http://schemas.microsoft.com/office/drawing/2014/main" xmlns="" val="485705556"/>
                    </a:ext>
                  </a:extLst>
                </a:gridCol>
                <a:gridCol w="1296652">
                  <a:extLst>
                    <a:ext uri="{9D8B030D-6E8A-4147-A177-3AD203B41FA5}">
                      <a16:colId xmlns:a16="http://schemas.microsoft.com/office/drawing/2014/main" xmlns="" val="1680731834"/>
                    </a:ext>
                  </a:extLst>
                </a:gridCol>
                <a:gridCol w="1321780">
                  <a:extLst>
                    <a:ext uri="{9D8B030D-6E8A-4147-A177-3AD203B41FA5}">
                      <a16:colId xmlns:a16="http://schemas.microsoft.com/office/drawing/2014/main" xmlns="" val="1106421420"/>
                    </a:ext>
                  </a:extLst>
                </a:gridCol>
                <a:gridCol w="1335389">
                  <a:extLst>
                    <a:ext uri="{9D8B030D-6E8A-4147-A177-3AD203B41FA5}">
                      <a16:colId xmlns:a16="http://schemas.microsoft.com/office/drawing/2014/main" xmlns="" val="3287272502"/>
                    </a:ext>
                  </a:extLst>
                </a:gridCol>
              </a:tblGrid>
              <a:tr h="59366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otal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dian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range)[IQR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ale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dian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range) [IQR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emale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dian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range) [IQR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51404713"/>
                  </a:ext>
                </a:extLst>
              </a:tr>
              <a:tr h="202823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onors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0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8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2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66546397"/>
                  </a:ext>
                </a:extLst>
              </a:tr>
              <a:tr h="202823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onations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0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9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1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80153704"/>
                  </a:ext>
                </a:extLst>
              </a:tr>
              <a:tr h="39824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ge [years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2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18-63)[24-42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2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18-63)[24-42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1.5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18-62)[24.3-44.5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46210916"/>
                  </a:ext>
                </a:extLst>
              </a:tr>
              <a:tr h="39824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eight [kg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8.5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51-126)[69-88.5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3.5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58-126) [74.5-92.3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9.5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51-103)[63.3-79.8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89745655"/>
                  </a:ext>
                </a:extLst>
              </a:tr>
              <a:tr h="39824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onor : recipient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eight ratio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.08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0.47-14.38)[0.89-1.33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.15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0.54-14.38) [0.95-1.37]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92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0.47-7.25)[0.78-1.27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4110130"/>
                  </a:ext>
                </a:extLst>
              </a:tr>
              <a:tr h="39824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r>
                        <a:rPr lang="en-US" sz="1000" kern="120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day apheresis only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0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7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3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59882165"/>
                  </a:ext>
                </a:extLst>
              </a:tr>
              <a:tr h="39824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ge [years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1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18-63)[24-41.8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2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18-63) [23.5-42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0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18-51)[24-41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86273346"/>
                  </a:ext>
                </a:extLst>
              </a:tr>
              <a:tr h="39824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eight [kg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9.5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51-126)[70-90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4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58-126) [74-92.5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0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51-103)[65-80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43103202"/>
                  </a:ext>
                </a:extLst>
              </a:tr>
              <a:tr h="39824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onor : recipient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eight ratio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.13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0.47-14.38)[0.91-1.38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.15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0.54-14.38) [0.97-1.38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.05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0.47-7.25)[0.81-1.63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70836443"/>
                  </a:ext>
                </a:extLst>
              </a:tr>
              <a:tr h="202823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r>
                        <a:rPr lang="en-US" sz="1000" kern="120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d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day apheresis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9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40730420"/>
                  </a:ext>
                </a:extLst>
              </a:tr>
              <a:tr h="39824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ge [years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8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26-62)[29.3-50.5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0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8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26-62)[31.5-53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20253178"/>
                  </a:ext>
                </a:extLst>
              </a:tr>
              <a:tr h="39824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eight [kg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8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51-88)[60.5-79.3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0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6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51-88)[59-74.5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26699825"/>
                  </a:ext>
                </a:extLst>
              </a:tr>
              <a:tr h="398244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onor : recipient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eight ratio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87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0.59-1.28)[0.72-0.94]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93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.84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0.59-1.28)[0.71-0.94]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9203" marR="39203" marT="6462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8400567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1297129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71</Words>
  <Application>Microsoft Office PowerPoint</Application>
  <PresentationFormat>On-screen Show (4:3)</PresentationFormat>
  <Paragraphs>225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Times New Roman</vt:lpstr>
      <vt:lpstr>Larissa</vt:lpstr>
      <vt:lpstr>Prism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ercinska, Eliza</dc:creator>
  <cp:lastModifiedBy>Pavithra K.</cp:lastModifiedBy>
  <cp:revision>22</cp:revision>
  <dcterms:created xsi:type="dcterms:W3CDTF">2021-01-25T12:34:29Z</dcterms:created>
  <dcterms:modified xsi:type="dcterms:W3CDTF">2021-03-30T05:01:18Z</dcterms:modified>
</cp:coreProperties>
</file>